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avi" ContentType="video/avi"/>
  <Default Extension="mp4" ContentType="video/unknown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92" r:id="rId2"/>
  </p:sldIdLst>
  <p:sldSz cx="16256000" cy="9144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512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u Ziyu" initials="LZ" lastIdx="1" clrIdx="0">
    <p:extLst>
      <p:ext uri="{19B8F6BF-5375-455C-9EA6-DF929625EA0E}">
        <p15:presenceInfo xmlns:p15="http://schemas.microsoft.com/office/powerpoint/2012/main" xmlns="" userId="e301b8b081b6494e" providerId="Windows Live"/>
      </p:ext>
    </p:extLst>
  </p:cmAuthor>
  <p:cmAuthor id="2" name="Prof. Stella W. PANG" initials="PSWP" lastIdx="4" clrIdx="1">
    <p:extLst>
      <p:ext uri="{19B8F6BF-5375-455C-9EA6-DF929625EA0E}">
        <p15:presenceInfo xmlns:p15="http://schemas.microsoft.com/office/powerpoint/2012/main" xmlns="" userId="S::pang@um.cityu.edu.hk::2e9774ef-ab5a-4845-aed5-32d50dec8a2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2" autoAdjust="0"/>
    <p:restoredTop sz="93826" autoAdjust="0"/>
  </p:normalViewPr>
  <p:slideViewPr>
    <p:cSldViewPr snapToGrid="0">
      <p:cViewPr>
        <p:scale>
          <a:sx n="100" d="100"/>
          <a:sy n="100" d="100"/>
        </p:scale>
        <p:origin x="-72" y="72"/>
      </p:cViewPr>
      <p:guideLst>
        <p:guide orient="horz" pos="2880"/>
        <p:guide pos="512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81B74E46-8D1B-499F-B400-208B795043C9}" type="datetimeFigureOut">
              <a:rPr lang="zh-CN" altLang="en-US" smtClean="0"/>
              <a:t>2020/6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5CE65D3-2D4D-4C66-9B3E-2AE352FD04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0989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48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96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44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91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739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87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035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184" algn="l" defTabSz="91429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32000" y="1496486"/>
            <a:ext cx="121920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4802718"/>
            <a:ext cx="12192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636" indent="0" algn="ctr">
              <a:buNone/>
              <a:defRPr sz="2667"/>
            </a:lvl2pPr>
            <a:lvl3pPr marL="1219272" indent="0" algn="ctr">
              <a:buNone/>
              <a:defRPr sz="2401"/>
            </a:lvl3pPr>
            <a:lvl4pPr marL="1828908" indent="0" algn="ctr">
              <a:buNone/>
              <a:defRPr sz="2133"/>
            </a:lvl4pPr>
            <a:lvl5pPr marL="2438544" indent="0" algn="ctr">
              <a:buNone/>
              <a:defRPr sz="2133"/>
            </a:lvl5pPr>
            <a:lvl6pPr marL="3048180" indent="0" algn="ctr">
              <a:buNone/>
              <a:defRPr sz="2133"/>
            </a:lvl6pPr>
            <a:lvl7pPr marL="3657816" indent="0" algn="ctr">
              <a:buNone/>
              <a:defRPr sz="2133"/>
            </a:lvl7pPr>
            <a:lvl8pPr marL="4267452" indent="0" algn="ctr">
              <a:buNone/>
              <a:defRPr sz="2133"/>
            </a:lvl8pPr>
            <a:lvl9pPr marL="4877089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579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2482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2" y="486836"/>
            <a:ext cx="3505199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486836"/>
            <a:ext cx="10312401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616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332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3" y="2279654"/>
            <a:ext cx="140208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3" y="6119286"/>
            <a:ext cx="140208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636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272" indent="0">
              <a:buNone/>
              <a:defRPr sz="2401">
                <a:solidFill>
                  <a:schemeClr val="tx1">
                    <a:tint val="75000"/>
                  </a:schemeClr>
                </a:solidFill>
              </a:defRPr>
            </a:lvl3pPr>
            <a:lvl4pPr marL="182890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54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818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816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452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708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349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1" y="2434167"/>
            <a:ext cx="690880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1" y="2434167"/>
            <a:ext cx="690880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682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9" y="486836"/>
            <a:ext cx="14020800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21" y="2241552"/>
            <a:ext cx="6877049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36" indent="0">
              <a:buNone/>
              <a:defRPr sz="2667" b="1"/>
            </a:lvl2pPr>
            <a:lvl3pPr marL="1219272" indent="0">
              <a:buNone/>
              <a:defRPr sz="2401" b="1"/>
            </a:lvl3pPr>
            <a:lvl4pPr marL="1828908" indent="0">
              <a:buNone/>
              <a:defRPr sz="2133" b="1"/>
            </a:lvl4pPr>
            <a:lvl5pPr marL="2438544" indent="0">
              <a:buNone/>
              <a:defRPr sz="2133" b="1"/>
            </a:lvl5pPr>
            <a:lvl6pPr marL="3048180" indent="0">
              <a:buNone/>
              <a:defRPr sz="2133" b="1"/>
            </a:lvl6pPr>
            <a:lvl7pPr marL="3657816" indent="0">
              <a:buNone/>
              <a:defRPr sz="2133" b="1"/>
            </a:lvl7pPr>
            <a:lvl8pPr marL="4267452" indent="0">
              <a:buNone/>
              <a:defRPr sz="2133" b="1"/>
            </a:lvl8pPr>
            <a:lvl9pPr marL="4877089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21" y="3340101"/>
            <a:ext cx="6877049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2" y="2241552"/>
            <a:ext cx="691091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36" indent="0">
              <a:buNone/>
              <a:defRPr sz="2667" b="1"/>
            </a:lvl2pPr>
            <a:lvl3pPr marL="1219272" indent="0">
              <a:buNone/>
              <a:defRPr sz="2401" b="1"/>
            </a:lvl3pPr>
            <a:lvl4pPr marL="1828908" indent="0">
              <a:buNone/>
              <a:defRPr sz="2133" b="1"/>
            </a:lvl4pPr>
            <a:lvl5pPr marL="2438544" indent="0">
              <a:buNone/>
              <a:defRPr sz="2133" b="1"/>
            </a:lvl5pPr>
            <a:lvl6pPr marL="3048180" indent="0">
              <a:buNone/>
              <a:defRPr sz="2133" b="1"/>
            </a:lvl6pPr>
            <a:lvl7pPr marL="3657816" indent="0">
              <a:buNone/>
              <a:defRPr sz="2133" b="1"/>
            </a:lvl7pPr>
            <a:lvl8pPr marL="4267452" indent="0">
              <a:buNone/>
              <a:defRPr sz="2133" b="1"/>
            </a:lvl8pPr>
            <a:lvl9pPr marL="4877089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2" y="3340101"/>
            <a:ext cx="6910917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69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590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650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21" y="609600"/>
            <a:ext cx="5242982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8" y="1316569"/>
            <a:ext cx="8229601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21" y="2743202"/>
            <a:ext cx="5242982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636" indent="0">
              <a:buNone/>
              <a:defRPr sz="1868"/>
            </a:lvl2pPr>
            <a:lvl3pPr marL="1219272" indent="0">
              <a:buNone/>
              <a:defRPr sz="1600"/>
            </a:lvl3pPr>
            <a:lvl4pPr marL="1828908" indent="0">
              <a:buNone/>
              <a:defRPr sz="1332"/>
            </a:lvl4pPr>
            <a:lvl5pPr marL="2438544" indent="0">
              <a:buNone/>
              <a:defRPr sz="1332"/>
            </a:lvl5pPr>
            <a:lvl6pPr marL="3048180" indent="0">
              <a:buNone/>
              <a:defRPr sz="1332"/>
            </a:lvl6pPr>
            <a:lvl7pPr marL="3657816" indent="0">
              <a:buNone/>
              <a:defRPr sz="1332"/>
            </a:lvl7pPr>
            <a:lvl8pPr marL="4267452" indent="0">
              <a:buNone/>
              <a:defRPr sz="1332"/>
            </a:lvl8pPr>
            <a:lvl9pPr marL="4877089" indent="0">
              <a:buNone/>
              <a:defRPr sz="133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625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21" y="609600"/>
            <a:ext cx="5242982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8" y="1316569"/>
            <a:ext cx="8229601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636" indent="0">
              <a:buNone/>
              <a:defRPr sz="3733"/>
            </a:lvl2pPr>
            <a:lvl3pPr marL="1219272" indent="0">
              <a:buNone/>
              <a:defRPr sz="3200"/>
            </a:lvl3pPr>
            <a:lvl4pPr marL="1828908" indent="0">
              <a:buNone/>
              <a:defRPr sz="2667"/>
            </a:lvl4pPr>
            <a:lvl5pPr marL="2438544" indent="0">
              <a:buNone/>
              <a:defRPr sz="2667"/>
            </a:lvl5pPr>
            <a:lvl6pPr marL="3048180" indent="0">
              <a:buNone/>
              <a:defRPr sz="2667"/>
            </a:lvl6pPr>
            <a:lvl7pPr marL="3657816" indent="0">
              <a:buNone/>
              <a:defRPr sz="2667"/>
            </a:lvl7pPr>
            <a:lvl8pPr marL="4267452" indent="0">
              <a:buNone/>
              <a:defRPr sz="2667"/>
            </a:lvl8pPr>
            <a:lvl9pPr marL="4877089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21" y="2743202"/>
            <a:ext cx="5242982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636" indent="0">
              <a:buNone/>
              <a:defRPr sz="1868"/>
            </a:lvl2pPr>
            <a:lvl3pPr marL="1219272" indent="0">
              <a:buNone/>
              <a:defRPr sz="1600"/>
            </a:lvl3pPr>
            <a:lvl4pPr marL="1828908" indent="0">
              <a:buNone/>
              <a:defRPr sz="1332"/>
            </a:lvl4pPr>
            <a:lvl5pPr marL="2438544" indent="0">
              <a:buNone/>
              <a:defRPr sz="1332"/>
            </a:lvl5pPr>
            <a:lvl6pPr marL="3048180" indent="0">
              <a:buNone/>
              <a:defRPr sz="1332"/>
            </a:lvl6pPr>
            <a:lvl7pPr marL="3657816" indent="0">
              <a:buNone/>
              <a:defRPr sz="1332"/>
            </a:lvl7pPr>
            <a:lvl8pPr marL="4267452" indent="0">
              <a:buNone/>
              <a:defRPr sz="1332"/>
            </a:lvl8pPr>
            <a:lvl9pPr marL="4877089" indent="0">
              <a:buNone/>
              <a:defRPr sz="133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331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2" y="486836"/>
            <a:ext cx="140208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2" y="2434167"/>
            <a:ext cx="140208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1" y="8475136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1C4F0-614C-4060-B30A-E9023C17FA5F}" type="datetimeFigureOut">
              <a:rPr lang="en-US" smtClean="0"/>
              <a:t>6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2" y="8475136"/>
            <a:ext cx="5486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1" y="8475136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A59D5-E1AD-4F5F-84CF-871FFEF6D8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035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272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817" indent="-304817" algn="l" defTabSz="1219272" rtl="0" eaLnBrk="1" latinLnBrk="0" hangingPunct="1">
        <a:lnSpc>
          <a:spcPct val="90000"/>
        </a:lnSpc>
        <a:spcBef>
          <a:spcPts val="1332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453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4091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727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4pPr>
      <a:lvl5pPr marL="2743361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5pPr>
      <a:lvl6pPr marL="3353000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6pPr>
      <a:lvl7pPr marL="3962636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7pPr>
      <a:lvl8pPr marL="4572272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8pPr>
      <a:lvl9pPr marL="5181908" indent="-304817" algn="l" defTabSz="1219272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1pPr>
      <a:lvl2pPr marL="609636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219272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3pPr>
      <a:lvl4pPr marL="1828908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4pPr>
      <a:lvl5pPr marL="2438544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5pPr>
      <a:lvl6pPr marL="3048180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6pPr>
      <a:lvl7pPr marL="3657816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7pPr>
      <a:lvl8pPr marL="4267452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8pPr>
      <a:lvl9pPr marL="4877089" algn="l" defTabSz="1219272" rtl="0" eaLnBrk="1" latinLnBrk="0" hangingPunct="1">
        <a:defRPr sz="24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2-181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23188" t="24011" b="14720"/>
          <a:stretch>
            <a:fillRect/>
          </a:stretch>
        </p:blipFill>
        <p:spPr>
          <a:xfrm>
            <a:off x="5644308" y="2246435"/>
            <a:ext cx="2520000" cy="1863623"/>
          </a:xfrm>
          <a:prstGeom prst="rect">
            <a:avLst/>
          </a:prstGeom>
        </p:spPr>
      </p:pic>
      <p:pic>
        <p:nvPicPr>
          <p:cNvPr id="5" name="23-2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/>
          <a:srcRect l="16025" t="31638" r="5512"/>
          <a:stretch>
            <a:fillRect/>
          </a:stretch>
        </p:blipFill>
        <p:spPr>
          <a:xfrm>
            <a:off x="8675898" y="2246430"/>
            <a:ext cx="2520000" cy="1884587"/>
          </a:xfrm>
          <a:prstGeom prst="rect">
            <a:avLst/>
          </a:prstGeom>
        </p:spPr>
      </p:pic>
      <p:cxnSp>
        <p:nvCxnSpPr>
          <p:cNvPr id="6" name="直接连接符 5"/>
          <p:cNvCxnSpPr/>
          <p:nvPr/>
        </p:nvCxnSpPr>
        <p:spPr>
          <a:xfrm>
            <a:off x="9991228" y="3421092"/>
            <a:ext cx="281353" cy="626012"/>
          </a:xfrm>
          <a:prstGeom prst="line">
            <a:avLst/>
          </a:prstGeom>
          <a:ln w="19050">
            <a:solidFill>
              <a:srgbClr val="FF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9977159" y="2893553"/>
            <a:ext cx="422030" cy="896564"/>
          </a:xfrm>
          <a:prstGeom prst="line">
            <a:avLst/>
          </a:prstGeom>
          <a:ln w="19050">
            <a:solidFill>
              <a:srgbClr val="FF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9654542" y="3421092"/>
            <a:ext cx="281353" cy="626012"/>
          </a:xfrm>
          <a:prstGeom prst="line">
            <a:avLst/>
          </a:prstGeom>
          <a:ln w="19050">
            <a:solidFill>
              <a:srgbClr val="FF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9447044" y="2921688"/>
            <a:ext cx="488853" cy="1030706"/>
          </a:xfrm>
          <a:prstGeom prst="line">
            <a:avLst/>
          </a:prstGeom>
          <a:ln w="19050">
            <a:solidFill>
              <a:srgbClr val="FF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47">
            <a:extLst>
              <a:ext uri="{FF2B5EF4-FFF2-40B4-BE49-F238E27FC236}">
                <a16:creationId xmlns:a16="http://schemas.microsoft.com/office/drawing/2014/main" xmlns="" id="{F0392F7D-18E7-4151-91A6-747F3D6DE03B}"/>
              </a:ext>
            </a:extLst>
          </p:cNvPr>
          <p:cNvSpPr txBox="1"/>
          <p:nvPr/>
        </p:nvSpPr>
        <p:spPr>
          <a:xfrm>
            <a:off x="10272582" y="3334912"/>
            <a:ext cx="6789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507204">
              <a:defRPr/>
            </a:pPr>
            <a:r>
              <a:rPr lang="en-US" altLang="zh-CN" sz="1600" b="1" kern="0" dirty="0">
                <a:latin typeface="Helvetica" panose="020B0604020202020204" pitchFamily="34" charset="0"/>
                <a:cs typeface="Helvetica" panose="020B0604020202020204" pitchFamily="34" charset="0"/>
              </a:rPr>
              <a:t>Tip</a:t>
            </a:r>
            <a:endParaRPr lang="en-US" sz="1600" b="1" kern="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1" name="直接箭头连接符 10"/>
          <p:cNvCxnSpPr/>
          <p:nvPr/>
        </p:nvCxnSpPr>
        <p:spPr>
          <a:xfrm flipH="1" flipV="1">
            <a:off x="10000413" y="3437041"/>
            <a:ext cx="392315" cy="6507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" name="组合 11"/>
          <p:cNvGrpSpPr/>
          <p:nvPr/>
        </p:nvGrpSpPr>
        <p:grpSpPr>
          <a:xfrm>
            <a:off x="10502082" y="3657786"/>
            <a:ext cx="687218" cy="264657"/>
            <a:chOff x="6316414" y="3307426"/>
            <a:chExt cx="687218" cy="264657"/>
          </a:xfrm>
        </p:grpSpPr>
        <p:sp>
          <p:nvSpPr>
            <p:cNvPr id="13" name="Text Box 10">
              <a:extLst>
                <a:ext uri="{FF2B5EF4-FFF2-40B4-BE49-F238E27FC236}">
                  <a16:creationId xmlns:a16="http://schemas.microsoft.com/office/drawing/2014/main" xmlns="" id="{0539587D-338B-469E-8853-CD35D9D616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16414" y="3307426"/>
              <a:ext cx="687218" cy="17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pPr algn="ctr" defTabSz="3985318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199" b="1" dirty="0">
                  <a:solidFill>
                    <a:srgbClr val="FFFFF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0 </a:t>
              </a:r>
              <a:r>
                <a:rPr lang="en-US" altLang="zh-CN" sz="1199" b="1" dirty="0" err="1">
                  <a:solidFill>
                    <a:srgbClr val="FFFFF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μm</a:t>
              </a:r>
              <a:endParaRPr lang="zh-CN" altLang="zh-CN" sz="1199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14" name="AutoShape 11">
              <a:extLst>
                <a:ext uri="{FF2B5EF4-FFF2-40B4-BE49-F238E27FC236}">
                  <a16:creationId xmlns:a16="http://schemas.microsoft.com/office/drawing/2014/main" xmlns="" id="{97C0BC4E-02EE-4A61-8E1A-18F1AF5F84F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16200000">
              <a:off x="6664833" y="3348883"/>
              <a:ext cx="0" cy="446400"/>
            </a:xfrm>
            <a:prstGeom prst="straightConnector1">
              <a:avLst/>
            </a:prstGeom>
            <a:noFill/>
            <a:ln w="60325">
              <a:solidFill>
                <a:srgbClr val="FFFFFF"/>
              </a:solidFill>
              <a:round/>
              <a:headEnd/>
              <a:tailEnd/>
            </a:ln>
          </p:spPr>
        </p:cxnSp>
      </p:grpSp>
      <p:sp>
        <p:nvSpPr>
          <p:cNvPr id="15" name="TextBox 15"/>
          <p:cNvSpPr txBox="1"/>
          <p:nvPr/>
        </p:nvSpPr>
        <p:spPr>
          <a:xfrm>
            <a:off x="4900093" y="954694"/>
            <a:ext cx="719931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ovie SV1. Cell movement on platforms with straight and bent gratings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tforms with (a) straight grating and pores and (b) bent grating and pores. The platforms had 2/2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nch/ridge and 1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ep straight/bent gratings on top, 1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a. and 14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ep pores in middle. 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9FFCDEED-CAD4-4A05-9D3D-D1C7B9FE525E}"/>
              </a:ext>
            </a:extLst>
          </p:cNvPr>
          <p:cNvSpPr txBox="1"/>
          <p:nvPr/>
        </p:nvSpPr>
        <p:spPr>
          <a:xfrm>
            <a:off x="6322638" y="4174799"/>
            <a:ext cx="1011124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99" b="1" dirty="0">
                <a:latin typeface="Helvetica" panose="020B0604020202020204" pitchFamily="34" charset="0"/>
                <a:cs typeface="Helvetica" panose="020B0604020202020204" pitchFamily="34" charset="0"/>
              </a:rPr>
              <a:t>(a)</a:t>
            </a:r>
            <a:endParaRPr lang="zh-CN" altLang="en-US" sz="1199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952092B1-E87B-473E-9A04-331710D634D4}"/>
              </a:ext>
            </a:extLst>
          </p:cNvPr>
          <p:cNvSpPr txBox="1"/>
          <p:nvPr/>
        </p:nvSpPr>
        <p:spPr>
          <a:xfrm>
            <a:off x="9513214" y="4174799"/>
            <a:ext cx="1011124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99" b="1" dirty="0">
                <a:latin typeface="Helvetica" panose="020B0604020202020204" pitchFamily="34" charset="0"/>
                <a:cs typeface="Helvetica" panose="020B0604020202020204" pitchFamily="34" charset="0"/>
              </a:rPr>
              <a:t>(b)</a:t>
            </a:r>
            <a:endParaRPr lang="zh-CN" altLang="en-US" sz="1199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24309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407</TotalTime>
  <Words>68</Words>
  <Application>Microsoft Office PowerPoint</Application>
  <PresentationFormat>Custom</PresentationFormat>
  <Paragraphs>6</Paragraphs>
  <Slides>1</Slides>
  <Notes>0</Notes>
  <HiddenSlides>0</HiddenSlides>
  <MMClips>2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ity University of Hong Kon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gzhang2</dc:creator>
  <cp:lastModifiedBy>Rez</cp:lastModifiedBy>
  <cp:revision>1123</cp:revision>
  <cp:lastPrinted>2017-10-19T02:03:29Z</cp:lastPrinted>
  <dcterms:created xsi:type="dcterms:W3CDTF">2017-04-07T12:14:27Z</dcterms:created>
  <dcterms:modified xsi:type="dcterms:W3CDTF">2020-06-02T18:04:08Z</dcterms:modified>
</cp:coreProperties>
</file>